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F4E88-D868-403F-9E4F-676DD51AB0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51CE6-A1ED-43A3-8F55-A2958F4CAC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AF279-6BAD-451D-B3BB-B87577495A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1D8CA-9C91-4D4A-88CC-18C5179535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0F688-80AB-4A40-B06C-AEDCF137EB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4FD21-21CF-42EF-B736-7823FD7566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92AFF-EAA9-48A7-B535-9E02F1E15B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D617B-B448-46C8-9F56-BB84E5C49C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FEF39-2F31-40B5-A639-94CE903766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F9607-59DE-41D3-A194-F0031529E8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E5F01-379D-41B3-B3AE-721268467E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19ED6-D2FF-41CE-9420-7B812EDDD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B94BB7-A9FA-4E50-A3DF-56B2914216A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609480" y="533520"/>
            <a:ext cx="8001000" cy="41097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82320" y="625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649760" y="625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400" y="4800600"/>
            <a:ext cx="867240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2000"/>
          </a:bodyPr>
          <a:p>
            <a:pPr marL="315360" indent="-315360" algn="just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2. GSH and GSSG levels in RR and RS cells at baseline and following 1 h treatment with 0.5 mM HX + 16 U/L XO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GSH concentration was higher in RR than RS cells both at baseline and following the HX/XO treatment, which was without significant effect in either cell type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At baseline, GSSG concentration was higher in RR than in RS cells; following the HX/XO treatment, there was no difference between the cell types. HX/XO treatment had no effect on GSSG concentration in RS cells, but resulted in a significant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decrease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in GSSG level in RR cells.  Statistical significance was determined by two-way ANOVA followed by ad-hoc Bonferroni post-tests; data are plotted as mean ± S.E.M (n=3-4).  *, p &lt; 0.05; ***, p &lt; 0.001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7T23:25:08Z</dcterms:created>
  <dc:creator>NChandiramani</dc:creator>
  <dc:description/>
  <dc:language>en-US</dc:language>
  <cp:lastModifiedBy>Marta Margeta</cp:lastModifiedBy>
  <dcterms:modified xsi:type="dcterms:W3CDTF">2010-07-13T20:06:26Z</dcterms:modified>
  <cp:revision>113</cp:revision>
  <dc:subject/>
  <dc:title>Slide 1</dc:title>
</cp:coreProperties>
</file>